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843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14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tmp"/><Relationship Id="rId4" Type="http://schemas.openxmlformats.org/officeDocument/2006/relationships/image" Target="../media/image3.tm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b="1" dirty="0"/>
              <a:t>Relationship between coronary artery calcification and myocardial ischemia on computed tomography myocardial perfusion in patients with stable chest pain</a:t>
            </a:r>
            <a:endParaRPr lang="en-US" altLang="en-US" b="1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43000" y="2457538"/>
            <a:ext cx="6400800" cy="135979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sz="1400" dirty="0"/>
              <a:t>Mohammed El Mahdiui, MD, Jeff M. Smit, MD, Alexander R. van Rosendael, MD, J. </a:t>
            </a:r>
            <a:r>
              <a:rPr lang="en-US" sz="1400" dirty="0" err="1"/>
              <a:t>Wouter</a:t>
            </a:r>
            <a:r>
              <a:rPr lang="en-US" sz="1400" dirty="0"/>
              <a:t> Jukema, MD PhD, Jeroen J. Bax, MD PhD, Arthur J.H.A. Scholte, MD PhD</a:t>
            </a:r>
          </a:p>
          <a:p>
            <a:pPr marL="0" lvl="1"/>
            <a:r>
              <a:rPr lang="en-US" sz="1800" dirty="0"/>
              <a:t>Department of Cardiology, Heart Lung Center, Leiden University Medical Center</a:t>
            </a:r>
            <a:endParaRPr lang="en-US" altLang="en-US" sz="105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Screen Clipping">
            <a:extLst>
              <a:ext uri="{FF2B5EF4-FFF2-40B4-BE49-F238E27FC236}">
                <a16:creationId xmlns:a16="http://schemas.microsoft.com/office/drawing/2014/main" id="{0B8D468D-5D44-471D-A355-765A96C66AD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4156" y="4003623"/>
            <a:ext cx="1441938" cy="635988"/>
          </a:xfrm>
          <a:prstGeom prst="rect">
            <a:avLst/>
          </a:prstGeom>
        </p:spPr>
      </p:pic>
      <p:pic>
        <p:nvPicPr>
          <p:cNvPr id="7" name="Picture 6" descr="Screen Clipping">
            <a:extLst>
              <a:ext uri="{FF2B5EF4-FFF2-40B4-BE49-F238E27FC236}">
                <a16:creationId xmlns:a16="http://schemas.microsoft.com/office/drawing/2014/main" id="{2226EB1C-F1B2-4BD2-A645-A6536B7FD09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5187" y="4809793"/>
            <a:ext cx="1808613" cy="53153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687A776-E7B6-4B43-A932-8B49093AFB7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66" b="8888"/>
          <a:stretch/>
        </p:blipFill>
        <p:spPr>
          <a:xfrm>
            <a:off x="1557424" y="3912669"/>
            <a:ext cx="1314905" cy="1491037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dirty="0"/>
              <a:t>1- Coronary artery calcium (CAC) score is a good indicator of the extent of coronary artery disease(CAD) and has shown excellent prognostic value</a:t>
            </a:r>
          </a:p>
          <a:p>
            <a:pPr marL="0" indent="0">
              <a:buNone/>
            </a:pPr>
            <a:r>
              <a:rPr lang="en-US" altLang="en-US" sz="2600" dirty="0"/>
              <a:t>2- CAC score correlates well with myocardial ischemia assessed on </a:t>
            </a:r>
            <a:r>
              <a:rPr lang="en-US" sz="2600" dirty="0"/>
              <a:t>single-photon emission computed tomography (SPECT) myocardial perfusion imaging (MPI).</a:t>
            </a:r>
            <a:endParaRPr lang="en-US" altLang="en-US" sz="2600" dirty="0"/>
          </a:p>
          <a:p>
            <a:pPr marL="0" indent="0">
              <a:buNone/>
            </a:pPr>
            <a:r>
              <a:rPr lang="en-US" altLang="en-US" sz="2600" dirty="0"/>
              <a:t>3- This relation has not been investigated for CAC score and c</a:t>
            </a:r>
            <a:r>
              <a:rPr lang="en-US" sz="2600" dirty="0"/>
              <a:t>omputed tomography myocardial perfusion (CTP)</a:t>
            </a:r>
            <a:r>
              <a:rPr lang="en-US" altLang="en-US" sz="2600" dirty="0"/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 </a:t>
            </a:r>
          </a:p>
          <a:p>
            <a:pPr marL="0" indent="0">
              <a:buNone/>
            </a:pPr>
            <a:r>
              <a:rPr lang="en-US" altLang="en-US" sz="2400" dirty="0"/>
              <a:t>	- </a:t>
            </a:r>
            <a:r>
              <a:rPr lang="en-US" altLang="en-US" sz="2000" dirty="0"/>
              <a:t>Retrospective analysis of prospectively acquired clinical data</a:t>
            </a:r>
          </a:p>
          <a:p>
            <a:pPr marL="514350" indent="-514350">
              <a:buAutoNum type="alphaUcPeriod" startAt="2"/>
            </a:pPr>
            <a:r>
              <a:rPr lang="en-US" altLang="en-US" sz="2400" dirty="0"/>
              <a:t>Study subjects: </a:t>
            </a:r>
          </a:p>
          <a:p>
            <a:pPr marL="0" indent="0">
              <a:buNone/>
            </a:pPr>
            <a:r>
              <a:rPr lang="en-US" altLang="en-US" sz="2400" dirty="0"/>
              <a:t>	- </a:t>
            </a:r>
            <a:r>
              <a:rPr lang="en-US" altLang="en-US" sz="2000" dirty="0"/>
              <a:t>131 </a:t>
            </a:r>
            <a:r>
              <a:rPr lang="en-US" sz="2000" dirty="0">
                <a:latin typeface="Arial" panose="020B0604020202020204" pitchFamily="34" charset="0"/>
                <a:ea typeface="Calibri" panose="020F0502020204030204" pitchFamily="34" charset="0"/>
              </a:rPr>
              <a:t>patients referred with stable chest pain, without 	previously known CAD. </a:t>
            </a:r>
          </a:p>
          <a:p>
            <a:pPr marL="0" indent="0">
              <a:buNone/>
            </a:pPr>
            <a:r>
              <a:rPr lang="en-US" altLang="en-US" sz="2400" dirty="0">
                <a:latin typeface="Arial" panose="020B0604020202020204" pitchFamily="34" charset="0"/>
              </a:rPr>
              <a:t>C.   </a:t>
            </a:r>
            <a:r>
              <a:rPr lang="en-US" altLang="en-US" sz="2400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000" dirty="0"/>
              <a:t>	</a:t>
            </a:r>
            <a:r>
              <a:rPr lang="en-US" altLang="en-US" sz="2400" dirty="0"/>
              <a:t>- </a:t>
            </a:r>
            <a:r>
              <a:rPr lang="en-US" altLang="en-US" sz="2000" dirty="0"/>
              <a:t>Relation between CAC score and reversible myocardial 	ischemia on CTP</a:t>
            </a:r>
          </a:p>
          <a:p>
            <a:pPr marL="457200" indent="-457200">
              <a:buAutoNum type="alphaUcPeriod" startAt="4"/>
            </a:pPr>
            <a:r>
              <a:rPr lang="en-US" altLang="en-US" sz="2400" dirty="0"/>
              <a:t>Study variables</a:t>
            </a: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	</a:t>
            </a:r>
            <a:r>
              <a:rPr lang="en-US" altLang="en-US" sz="2400" dirty="0"/>
              <a:t>-</a:t>
            </a:r>
            <a:r>
              <a:rPr lang="en-US" altLang="en-US" sz="2000" dirty="0"/>
              <a:t> Age, gender, BMI, cardiovascular risk factors, medication, 	CAC score, summed difference score (SDS)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48B6423F-37A1-44B9-8A6C-5014F390F19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1530936"/>
            <a:ext cx="6213205" cy="3701555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7BC5FDB-E29B-42D4-AAFA-2FBB7F4EE0F5}"/>
              </a:ext>
            </a:extLst>
          </p:cNvPr>
          <p:cNvSpPr/>
          <p:nvPr/>
        </p:nvSpPr>
        <p:spPr>
          <a:xfrm>
            <a:off x="609600" y="5398018"/>
            <a:ext cx="8229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Relationship between patients with inducible myocardial ischemia and CAC score subgroups. The percentage of subjects with inducible myocardial ischemia on CTP increased with increasing CAC score severity. </a:t>
            </a:r>
          </a:p>
          <a:p>
            <a:r>
              <a:rPr lang="en-US" sz="1200" b="1" dirty="0"/>
              <a:t>CAC score: coronary artery calcium score</a:t>
            </a:r>
            <a:endParaRPr lang="nl-NL" sz="1200" b="1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pic>
        <p:nvPicPr>
          <p:cNvPr id="3" name="Content Placeholder 2">
            <a:extLst>
              <a:ext uri="{FF2B5EF4-FFF2-40B4-BE49-F238E27FC236}">
                <a16:creationId xmlns:a16="http://schemas.microsoft.com/office/drawing/2014/main" id="{B37D62CE-3449-45FE-88C8-C576B1A5C6E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400" y="1381568"/>
            <a:ext cx="4622120" cy="4184275"/>
          </a:xfrm>
          <a:ln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AA65A00-6843-4AED-BD37-E4904550D408}"/>
              </a:ext>
            </a:extLst>
          </p:cNvPr>
          <p:cNvSpPr/>
          <p:nvPr/>
        </p:nvSpPr>
        <p:spPr>
          <a:xfrm>
            <a:off x="646072" y="5657027"/>
            <a:ext cx="81534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Relationship between extent of inducible myocardial ischemia on CTP and CAC score subgroups. </a:t>
            </a:r>
          </a:p>
          <a:p>
            <a:pPr>
              <a:spcAft>
                <a:spcPts val="0"/>
              </a:spcAft>
            </a:pPr>
            <a:r>
              <a:rPr lang="en-US" sz="1200" b="1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AC score: coronary artery calcium score, SDS: summed difference score.</a:t>
            </a:r>
            <a:endParaRPr lang="nl-NL" sz="1200" b="1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sz="2600" dirty="0"/>
              <a:t>In a population of symptomatic patients, the majority of patients with extensive calcification (CAC score ≥1000) had evidence of inducible myocardial ischemia on CTP. </a:t>
            </a:r>
            <a:r>
              <a:rPr lang="en-US" altLang="en-US" sz="2600" dirty="0"/>
              <a:t> 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US" sz="2600" dirty="0"/>
              <a:t>CAC score was an independent predictor of inducible myocardial ischemia on CTP.</a:t>
            </a:r>
            <a:endParaRPr lang="en-US" altLang="en-US" sz="26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</TotalTime>
  <Words>389</Words>
  <Application>Microsoft Office PowerPoint</Application>
  <PresentationFormat>On-screen Show (4:3)</PresentationFormat>
  <Paragraphs>4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Relationship between coronary artery calcification and myocardial ischemia on computed tomography myocardial perfusion in patients with stable chest pain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hdiui, M. el (HARTZ)</cp:lastModifiedBy>
  <cp:revision>110</cp:revision>
  <dcterms:created xsi:type="dcterms:W3CDTF">2011-04-18T21:44:13Z</dcterms:created>
  <dcterms:modified xsi:type="dcterms:W3CDTF">2019-08-14T07:39:56Z</dcterms:modified>
</cp:coreProperties>
</file>